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06141-D03B-4D3F-9D73-6F59DE09B21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CE440A-5010-48BC-80DD-1A57E991383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Documents and Settings\Marti\Desktop\Freq Distribution graphs 10-7-2013\Slide2.TIF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3400" y="582826"/>
            <a:ext cx="8305800" cy="60465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16:36Z</dcterms:created>
  <dcterms:modified xsi:type="dcterms:W3CDTF">2013-11-13T12:17:30Z</dcterms:modified>
</cp:coreProperties>
</file>